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png" ContentType="image/png"/>
  <Override PartName="/ppt/media/image4.png" ContentType="image/pn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CA10EF-26D1-4F3D-959D-C41597B0A17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36E32-2DDD-4DE7-AAF5-85EAE607F9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53589A-1A84-48F8-B2E0-00C3C5BE97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3B6016-E90D-4C98-835D-4E7E29D195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D2F287-62EB-4991-8BD2-03BEB5DE48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D9B3A-2E9F-45B2-9FDE-56A1A73EBC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004C55-D26E-459C-AF5F-344C484829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019AB9-6A91-41CC-8FE5-94FCEACDDB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2FFD99-05B5-44E2-8E08-78ADB23762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EE95D7-A89E-4286-BF01-C54BF99DBB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16813-F126-4B8E-912D-CEF4D9BDA2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3B2C0D-04DF-4433-AD69-C082A3159E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6FFF54-D029-4B50-9674-C328FEB2E99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package" Target="../embeddings/oleObject1.xlsx"/><Relationship Id="rId3" Type="http://schemas.openxmlformats.org/officeDocument/2006/relationships/image" Target="../media/image2.wmf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57200" y="485280"/>
            <a:ext cx="7853400" cy="5917320"/>
            <a:chOff x="457200" y="485280"/>
            <a:chExt cx="7853400" cy="591732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23126" t="19999" r="14375" b="31666"/>
            <a:stretch/>
          </p:blipFill>
          <p:spPr>
            <a:xfrm>
              <a:off x="690480" y="3535200"/>
              <a:ext cx="7620120" cy="10670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3" name=""/>
            <p:cNvGrpSpPr/>
            <p:nvPr/>
          </p:nvGrpSpPr>
          <p:grpSpPr>
            <a:xfrm>
              <a:off x="457200" y="485280"/>
              <a:ext cx="7850160" cy="5917320"/>
              <a:chOff x="457200" y="485280"/>
              <a:chExt cx="7850160" cy="5917320"/>
            </a:xfrm>
          </p:grpSpPr>
          <p:graphicFrame>
            <p:nvGraphicFramePr>
              <p:cNvPr id="44" name=""/>
              <p:cNvGraphicFramePr/>
              <p:nvPr/>
            </p:nvGraphicFramePr>
            <p:xfrm>
              <a:off x="990720" y="654120"/>
              <a:ext cx="7162560" cy="2181240"/>
            </p:xfrm>
            <a:graphic>
              <a:graphicData uri="http://schemas.openxmlformats.org/presentationml/2006/ole">
                <p:oleObj progId="Excel.Sheet.12" r:id="rId2" spid="">
                  <p:embed/>
                  <p:pic>
                    <p:nvPicPr>
                      <p:cNvPr id="45" name="" descr=""/>
                      <p:cNvPicPr/>
                      <p:nvPr/>
                    </p:nvPicPr>
                    <p:blipFill>
                      <a:blip r:embed="rId3"/>
                      <a:stretch/>
                    </p:blipFill>
                    <p:spPr>
                      <a:xfrm>
                        <a:off x="990720" y="654120"/>
                        <a:ext cx="7162560" cy="21812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46" name=""/>
              <p:cNvSpPr/>
              <p:nvPr/>
            </p:nvSpPr>
            <p:spPr>
              <a:xfrm>
                <a:off x="1662120" y="825480"/>
                <a:ext cx="6357960" cy="1069920"/>
              </a:xfrm>
              <a:prstGeom prst="rect">
                <a:avLst/>
              </a:prstGeom>
              <a:solidFill>
                <a:srgbClr val="bbe0e3">
                  <a:alpha val="35000"/>
                </a:srgbClr>
              </a:solidFill>
              <a:ln cap="rnd" w="9360">
                <a:solidFill>
                  <a:srgbClr val="969696"/>
                </a:solidFill>
                <a:custDash>
                  <a:ds d="1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3581280" y="6126120"/>
                <a:ext cx="1600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Kappa Score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 rot="16200000">
                <a:off x="99720" y="1223280"/>
                <a:ext cx="1752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Kappa Scor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49" name="" descr=""/>
              <p:cNvPicPr/>
              <p:nvPr/>
            </p:nvPicPr>
            <p:blipFill>
              <a:blip r:embed="rId4"/>
              <a:srcRect l="23752" t="19999" r="14375" b="35002"/>
              <a:stretch/>
            </p:blipFill>
            <p:spPr>
              <a:xfrm>
                <a:off x="762120" y="4754520"/>
                <a:ext cx="7543800" cy="1219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0" name=""/>
              <p:cNvSpPr/>
              <p:nvPr/>
            </p:nvSpPr>
            <p:spPr>
              <a:xfrm rot="16200000">
                <a:off x="-318600" y="4159080"/>
                <a:ext cx="1828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Densit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1676520" y="1935000"/>
                <a:ext cx="2057400" cy="3810240"/>
              </a:xfrm>
              <a:prstGeom prst="line">
                <a:avLst/>
              </a:prstGeom>
              <a:ln w="9360">
                <a:solidFill>
                  <a:srgbClr val="808080"/>
                </a:solidFill>
                <a:prstDash val="lg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8001000" y="1935000"/>
                <a:ext cx="152280" cy="3886200"/>
              </a:xfrm>
              <a:prstGeom prst="line">
                <a:avLst/>
              </a:prstGeom>
              <a:ln w="9360">
                <a:solidFill>
                  <a:srgbClr val="808080"/>
                </a:solidFill>
                <a:prstDash val="lg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3" name=""/>
              <p:cNvGrpSpPr/>
              <p:nvPr/>
            </p:nvGrpSpPr>
            <p:grpSpPr>
              <a:xfrm>
                <a:off x="1219320" y="4589280"/>
                <a:ext cx="304560" cy="164880"/>
                <a:chOff x="1219320" y="4589280"/>
                <a:chExt cx="304560" cy="164880"/>
              </a:xfrm>
            </p:grpSpPr>
            <p:sp>
              <p:nvSpPr>
                <p:cNvPr id="54" name=""/>
                <p:cNvSpPr/>
                <p:nvPr/>
              </p:nvSpPr>
              <p:spPr>
                <a:xfrm>
                  <a:off x="1219320" y="4589280"/>
                  <a:ext cx="304560" cy="86040"/>
                </a:xfrm>
                <a:custGeom>
                  <a:avLst/>
                  <a:gdLst/>
                  <a:ahLst/>
                  <a:rect l="l" t="t" r="r" b="b"/>
                  <a:pathLst>
                    <a:path w="384" h="104">
                      <a:moveTo>
                        <a:pt x="0" y="56"/>
                      </a:moveTo>
                      <a:cubicBezTo>
                        <a:pt x="12" y="36"/>
                        <a:pt x="24" y="16"/>
                        <a:pt x="48" y="8"/>
                      </a:cubicBezTo>
                      <a:cubicBezTo>
                        <a:pt x="72" y="0"/>
                        <a:pt x="120" y="0"/>
                        <a:pt x="144" y="8"/>
                      </a:cubicBezTo>
                      <a:cubicBezTo>
                        <a:pt x="168" y="16"/>
                        <a:pt x="176" y="40"/>
                        <a:pt x="192" y="56"/>
                      </a:cubicBezTo>
                      <a:cubicBezTo>
                        <a:pt x="208" y="72"/>
                        <a:pt x="208" y="104"/>
                        <a:pt x="240" y="104"/>
                      </a:cubicBezTo>
                      <a:cubicBezTo>
                        <a:pt x="272" y="104"/>
                        <a:pt x="360" y="72"/>
                        <a:pt x="384" y="56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240" bIns="39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"/>
                <p:cNvSpPr/>
                <p:nvPr/>
              </p:nvSpPr>
              <p:spPr>
                <a:xfrm>
                  <a:off x="1219320" y="4668480"/>
                  <a:ext cx="304560" cy="85680"/>
                </a:xfrm>
                <a:custGeom>
                  <a:avLst/>
                  <a:gdLst/>
                  <a:ahLst/>
                  <a:rect l="l" t="t" r="r" b="b"/>
                  <a:pathLst>
                    <a:path w="384" h="104">
                      <a:moveTo>
                        <a:pt x="0" y="56"/>
                      </a:moveTo>
                      <a:cubicBezTo>
                        <a:pt x="12" y="36"/>
                        <a:pt x="24" y="16"/>
                        <a:pt x="48" y="8"/>
                      </a:cubicBezTo>
                      <a:cubicBezTo>
                        <a:pt x="72" y="0"/>
                        <a:pt x="120" y="0"/>
                        <a:pt x="144" y="8"/>
                      </a:cubicBezTo>
                      <a:cubicBezTo>
                        <a:pt x="168" y="16"/>
                        <a:pt x="176" y="40"/>
                        <a:pt x="192" y="56"/>
                      </a:cubicBezTo>
                      <a:cubicBezTo>
                        <a:pt x="208" y="72"/>
                        <a:pt x="208" y="104"/>
                        <a:pt x="240" y="104"/>
                      </a:cubicBezTo>
                      <a:cubicBezTo>
                        <a:pt x="272" y="104"/>
                        <a:pt x="360" y="72"/>
                        <a:pt x="384" y="56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6" name=""/>
              <p:cNvSpPr/>
              <p:nvPr/>
            </p:nvSpPr>
            <p:spPr>
              <a:xfrm>
                <a:off x="3772080" y="5773680"/>
                <a:ext cx="761760" cy="76320"/>
              </a:xfrm>
              <a:prstGeom prst="rtTriangle">
                <a:avLst/>
              </a:prstGeom>
              <a:solidFill>
                <a:srgbClr val="bbe0e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1960" bIns="-21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7" name="" descr=""/>
              <p:cNvPicPr/>
              <p:nvPr/>
            </p:nvPicPr>
            <p:blipFill>
              <a:blip r:embed="rId5"/>
              <a:srcRect l="28121" t="78914" r="14399" b="18302"/>
              <a:stretch/>
            </p:blipFill>
            <p:spPr>
              <a:xfrm>
                <a:off x="1300320" y="5878440"/>
                <a:ext cx="7007040" cy="25416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sp>
        <p:nvSpPr>
          <p:cNvPr id="58" name=""/>
          <p:cNvSpPr/>
          <p:nvPr/>
        </p:nvSpPr>
        <p:spPr>
          <a:xfrm>
            <a:off x="2133720" y="2957400"/>
            <a:ext cx="7010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 of Overlapped Annotations for Given Gene-Gene Pai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57200" y="94284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80880" y="3471840"/>
            <a:ext cx="38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33520" y="166680"/>
            <a:ext cx="792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e Influence of Overlapped Annotations Number on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Kapp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Scor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1676160" y="4853160"/>
            <a:ext cx="75960" cy="228600"/>
          </a:xfrm>
          <a:prstGeom prst="line">
            <a:avLst/>
          </a:prstGeom>
          <a:ln w="9360">
            <a:solidFill>
              <a:srgbClr val="ff33cc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523880" y="4653000"/>
            <a:ext cx="289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33cc"/>
                </a:solidFill>
                <a:latin typeface="Arial"/>
              </a:rPr>
              <a:t>All human gene-gene pairs without default filt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133720" y="5186520"/>
            <a:ext cx="0" cy="380880"/>
          </a:xfrm>
          <a:prstGeom prst="line">
            <a:avLst/>
          </a:prstGeom>
          <a:ln w="936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752480" y="4941720"/>
            <a:ext cx="274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333399"/>
                </a:solidFill>
                <a:latin typeface="Arial"/>
              </a:rPr>
              <a:t>All human gene-gene pairs with default filt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17T19:15:51Z</dcterms:created>
  <dc:creator>DaWei Huang</dc:creator>
  <dc:description/>
  <dc:language>en-US</dc:language>
  <cp:lastModifiedBy>DaWei Huang</cp:lastModifiedBy>
  <dcterms:modified xsi:type="dcterms:W3CDTF">2006-10-25T17:14:33Z</dcterms:modified>
  <cp:revision>19</cp:revision>
  <dc:subject/>
  <dc:title>Slide 1</dc:title>
</cp:coreProperties>
</file>